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59.jpeg" ContentType="image/jpeg"/>
  <Override PartName="/ppt/media/image42.jpeg" ContentType="image/jpeg"/>
  <Override PartName="/ppt/media/image58.jpeg" ContentType="image/jpeg"/>
  <Override PartName="/ppt/media/image57.jpeg" ContentType="image/jpeg"/>
  <Override PartName="/ppt/media/image56.jpeg" ContentType="image/jpeg"/>
  <Override PartName="/ppt/media/image55.jpeg" ContentType="image/jpeg"/>
  <Override PartName="/ppt/media/image54.jpeg" ContentType="image/jpeg"/>
  <Override PartName="/ppt/media/image53.jpeg" ContentType="image/jpeg"/>
  <Override PartName="/ppt/media/image49.jpeg" ContentType="image/jpeg"/>
  <Override PartName="/ppt/media/image48.jpeg" ContentType="image/jpeg"/>
  <Override PartName="/ppt/media/image47.jpeg" ContentType="image/jpeg"/>
  <Override PartName="/ppt/media/image46.jpeg" ContentType="image/jpeg"/>
  <Override PartName="/ppt/media/image45.jpeg" ContentType="image/jpeg"/>
  <Override PartName="/ppt/media/image44.jpeg" ContentType="image/jpeg"/>
  <Override PartName="/ppt/media/image43.jpeg" ContentType="image/jpeg"/>
  <Override PartName="/ppt/media/image34.jpeg" ContentType="image/jpeg"/>
  <Override PartName="/ppt/media/image33.jpeg" ContentType="image/jpeg"/>
  <Override PartName="/ppt/media/image32.jpeg" ContentType="image/jpeg"/>
  <Override PartName="/ppt/media/image1.jpeg" ContentType="image/jpeg"/>
  <Override PartName="/ppt/media/image35.jpeg" ContentType="image/jpeg"/>
  <Override PartName="/ppt/media/image22.jpeg" ContentType="image/jpeg"/>
  <Override PartName="/ppt/media/image41.jpeg" ContentType="image/jpeg"/>
  <Override PartName="/ppt/media/image14.jpeg" ContentType="image/jpeg"/>
  <Override PartName="/ppt/media/image15.jpeg" ContentType="image/jpeg"/>
  <Override PartName="/ppt/media/image20.jpeg" ContentType="image/jpeg"/>
  <Override PartName="/ppt/media/image21.jpeg" ContentType="image/jpeg"/>
  <Override PartName="/ppt/media/image16.jpeg" ContentType="image/jpeg"/>
  <Override PartName="/ppt/media/image3.jpeg" ContentType="image/jpeg"/>
  <Override PartName="/ppt/media/image37.jpeg" ContentType="image/jpeg"/>
  <Override PartName="/ppt/media/image60.jpeg" ContentType="image/jpeg"/>
  <Override PartName="/ppt/media/image77.jpeg" ContentType="image/jpeg"/>
  <Override PartName="/ppt/media/image17.jpeg" ContentType="image/jpeg"/>
  <Override PartName="/ppt/media/image61.jpeg" ContentType="image/jpeg"/>
  <Override PartName="/ppt/media/image4.jpeg" ContentType="image/jpeg"/>
  <Override PartName="/ppt/media/image18.jpeg" ContentType="image/jpeg"/>
  <Override PartName="/ppt/media/image62.jpeg" ContentType="image/jpeg"/>
  <Override PartName="/ppt/media/image5.jpeg" ContentType="image/jpeg"/>
  <Override PartName="/ppt/media/image19.jpeg" ContentType="image/jpeg"/>
  <Override PartName="/ppt/media/image63.jpeg" ContentType="image/jpeg"/>
  <Override PartName="/ppt/media/image6.jpeg" ContentType="image/jpeg"/>
  <Override PartName="/ppt/media/image76.jpeg" ContentType="image/jpeg"/>
  <Override PartName="/ppt/media/image75.jpeg" ContentType="image/jpeg"/>
  <Override PartName="/ppt/media/image74.jpeg" ContentType="image/jpeg"/>
  <Override PartName="/ppt/media/image69.jpeg" ContentType="image/jpeg"/>
  <Override PartName="/ppt/media/image73.jpeg" ContentType="image/jpeg"/>
  <Override PartName="/ppt/media/image68.jpeg" ContentType="image/jpeg"/>
  <Override PartName="/ppt/media/image72.jpeg" ContentType="image/jpeg"/>
  <Override PartName="/ppt/media/image67.jpeg" ContentType="image/jpeg"/>
  <Override PartName="/ppt/media/image71.jpeg" ContentType="image/jpeg"/>
  <Override PartName="/ppt/media/image66.jpeg" ContentType="image/jpeg"/>
  <Override PartName="/ppt/media/image9.jpeg" ContentType="image/jpeg"/>
  <Override PartName="/ppt/media/image70.jpeg" ContentType="image/jpeg"/>
  <Override PartName="/ppt/media/image65.jpeg" ContentType="image/jpeg"/>
  <Override PartName="/ppt/media/image8.jpeg" ContentType="image/jpeg"/>
  <Override PartName="/ppt/media/image39.jpeg" ContentType="image/jpeg"/>
  <Override PartName="/ppt/media/image64.jpeg" ContentType="image/jpeg"/>
  <Override PartName="/ppt/media/image7.jpeg" ContentType="image/jpeg"/>
  <Override PartName="/ppt/media/image38.jpeg" ContentType="image/jpeg"/>
  <Override PartName="/ppt/media/image23.jpeg" ContentType="image/jpeg"/>
  <Override PartName="/ppt/media/image2.jpeg" ContentType="image/jpeg"/>
  <Override PartName="/ppt/media/image36.jpeg" ContentType="image/jpeg"/>
  <Override PartName="/ppt/media/image24.jpeg" ContentType="image/jpeg"/>
  <Override PartName="/ppt/media/image25.jpeg" ContentType="image/jpeg"/>
  <Override PartName="/ppt/media/image26.jpeg" ContentType="image/jpeg"/>
  <Override PartName="/ppt/media/image50.jpeg" ContentType="image/jpeg"/>
  <Override PartName="/ppt/media/image51.jpeg" ContentType="image/jpeg"/>
  <Override PartName="/ppt/media/image12.jpeg" ContentType="image/jpeg"/>
  <Override PartName="/ppt/media/image29.jpeg" ContentType="image/jpeg"/>
  <Override PartName="/ppt/media/image52.jpeg" ContentType="image/jpeg"/>
  <Override PartName="/ppt/media/image27.jpeg" ContentType="image/jpeg"/>
  <Override PartName="/ppt/media/image10.jpeg" ContentType="image/jpeg"/>
  <Override PartName="/ppt/media/image13.jpeg" ContentType="image/jpeg"/>
  <Override PartName="/ppt/media/image40.jpeg" ContentType="image/jpeg"/>
  <Override PartName="/ppt/media/image28.jpeg" ContentType="image/jpeg"/>
  <Override PartName="/ppt/media/image11.jpeg" ContentType="image/jpeg"/>
  <Override PartName="/ppt/media/image30.jpeg" ContentType="image/jpeg"/>
  <Override PartName="/ppt/media/image31.jpeg" ContentType="image/jpe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22B8E6-8287-4D17-B2D4-2AC38281492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AE08E6-E91C-41C2-ABBC-98B31D42801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00A8EF-A560-45F9-8A74-4B2EFA71409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C910E4-7EB1-49D3-B3BD-48360C813EC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97295C-9F74-4BC9-9DFD-D0261181E4C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90104F-07C5-4853-AE51-31A2192F75D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A8C8AC-9FD1-417C-B07C-2DD6549F064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1B6A9E-797D-467A-865B-3E40738761F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3A4149-5AD6-4F01-9423-8FF67A0CB7F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EEFD39-C37C-47CF-BE88-2B236083225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015CF7-80A6-4170-A4C5-178C2310A31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6A08AD-D649-48AC-A563-8B9F34FD0C0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F4A14C5-795F-4BCA-91EF-1DD56BCE476D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5.jpeg"/><Relationship Id="rId6" Type="http://schemas.openxmlformats.org/officeDocument/2006/relationships/image" Target="../media/image6.jpeg"/><Relationship Id="rId7" Type="http://schemas.openxmlformats.org/officeDocument/2006/relationships/image" Target="../media/image7.jpeg"/><Relationship Id="rId8" Type="http://schemas.openxmlformats.org/officeDocument/2006/relationships/image" Target="../media/image8.jpeg"/><Relationship Id="rId9" Type="http://schemas.openxmlformats.org/officeDocument/2006/relationships/image" Target="../media/image9.jpeg"/><Relationship Id="rId10" Type="http://schemas.openxmlformats.org/officeDocument/2006/relationships/image" Target="../media/image10.jpeg"/><Relationship Id="rId11" Type="http://schemas.openxmlformats.org/officeDocument/2006/relationships/image" Target="../media/image11.jpeg"/><Relationship Id="rId12" Type="http://schemas.openxmlformats.org/officeDocument/2006/relationships/image" Target="../media/image12.jpeg"/><Relationship Id="rId13" Type="http://schemas.openxmlformats.org/officeDocument/2006/relationships/image" Target="../media/image13.jpeg"/><Relationship Id="rId14" Type="http://schemas.openxmlformats.org/officeDocument/2006/relationships/image" Target="../media/image14.jpeg"/><Relationship Id="rId15" Type="http://schemas.openxmlformats.org/officeDocument/2006/relationships/image" Target="../media/image15.jpeg"/><Relationship Id="rId16" Type="http://schemas.openxmlformats.org/officeDocument/2006/relationships/image" Target="../media/image16.jpeg"/><Relationship Id="rId17" Type="http://schemas.openxmlformats.org/officeDocument/2006/relationships/image" Target="../media/image17.jpeg"/><Relationship Id="rId18" Type="http://schemas.openxmlformats.org/officeDocument/2006/relationships/image" Target="../media/image18.jpeg"/><Relationship Id="rId19" Type="http://schemas.openxmlformats.org/officeDocument/2006/relationships/image" Target="../media/image19.jpeg"/><Relationship Id="rId20" Type="http://schemas.openxmlformats.org/officeDocument/2006/relationships/image" Target="../media/image20.jpeg"/><Relationship Id="rId21" Type="http://schemas.openxmlformats.org/officeDocument/2006/relationships/image" Target="../media/image21.jpeg"/><Relationship Id="rId22" Type="http://schemas.openxmlformats.org/officeDocument/2006/relationships/image" Target="../media/image22.jpeg"/><Relationship Id="rId23" Type="http://schemas.openxmlformats.org/officeDocument/2006/relationships/image" Target="../media/image23.jpeg"/><Relationship Id="rId24" Type="http://schemas.openxmlformats.org/officeDocument/2006/relationships/image" Target="../media/image24.jpeg"/><Relationship Id="rId25" Type="http://schemas.openxmlformats.org/officeDocument/2006/relationships/image" Target="../media/image25.jpeg"/><Relationship Id="rId26" Type="http://schemas.openxmlformats.org/officeDocument/2006/relationships/image" Target="../media/image26.jpeg"/><Relationship Id="rId27" Type="http://schemas.openxmlformats.org/officeDocument/2006/relationships/image" Target="../media/image27.jpeg"/><Relationship Id="rId28" Type="http://schemas.openxmlformats.org/officeDocument/2006/relationships/image" Target="../media/image28.jpeg"/><Relationship Id="rId29" Type="http://schemas.openxmlformats.org/officeDocument/2006/relationships/image" Target="../media/image29.jpeg"/><Relationship Id="rId30" Type="http://schemas.openxmlformats.org/officeDocument/2006/relationships/image" Target="../media/image30.jpeg"/><Relationship Id="rId31" Type="http://schemas.openxmlformats.org/officeDocument/2006/relationships/image" Target="../media/image31.jpeg"/><Relationship Id="rId32" Type="http://schemas.openxmlformats.org/officeDocument/2006/relationships/image" Target="../media/image32.jpeg"/><Relationship Id="rId33" Type="http://schemas.openxmlformats.org/officeDocument/2006/relationships/image" Target="../media/image33.jpeg"/><Relationship Id="rId34" Type="http://schemas.openxmlformats.org/officeDocument/2006/relationships/image" Target="../media/image34.jpeg"/><Relationship Id="rId35" Type="http://schemas.openxmlformats.org/officeDocument/2006/relationships/image" Target="../media/image35.jpeg"/><Relationship Id="rId36" Type="http://schemas.openxmlformats.org/officeDocument/2006/relationships/image" Target="../media/image36.jpeg"/><Relationship Id="rId37" Type="http://schemas.openxmlformats.org/officeDocument/2006/relationships/image" Target="../media/image37.jpeg"/><Relationship Id="rId38" Type="http://schemas.openxmlformats.org/officeDocument/2006/relationships/image" Target="../media/image38.jpeg"/><Relationship Id="rId39" Type="http://schemas.openxmlformats.org/officeDocument/2006/relationships/image" Target="../media/image39.jpeg"/><Relationship Id="rId40" Type="http://schemas.openxmlformats.org/officeDocument/2006/relationships/image" Target="../media/image40.jpeg"/><Relationship Id="rId41" Type="http://schemas.openxmlformats.org/officeDocument/2006/relationships/image" Target="../media/image39.jpeg"/><Relationship Id="rId42" Type="http://schemas.openxmlformats.org/officeDocument/2006/relationships/image" Target="../media/image37.jpeg"/><Relationship Id="rId43" Type="http://schemas.openxmlformats.org/officeDocument/2006/relationships/image" Target="../media/image41.jpeg"/><Relationship Id="rId44" Type="http://schemas.openxmlformats.org/officeDocument/2006/relationships/image" Target="../media/image42.jpeg"/><Relationship Id="rId45" Type="http://schemas.openxmlformats.org/officeDocument/2006/relationships/image" Target="../media/image43.jpeg"/><Relationship Id="rId46" Type="http://schemas.openxmlformats.org/officeDocument/2006/relationships/image" Target="../media/image44.jpeg"/><Relationship Id="rId47" Type="http://schemas.openxmlformats.org/officeDocument/2006/relationships/image" Target="../media/image45.jpeg"/><Relationship Id="rId48" Type="http://schemas.openxmlformats.org/officeDocument/2006/relationships/image" Target="../media/image46.jpeg"/><Relationship Id="rId49" Type="http://schemas.openxmlformats.org/officeDocument/2006/relationships/image" Target="../media/image47.jpeg"/><Relationship Id="rId50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48.jpeg"/><Relationship Id="rId2" Type="http://schemas.openxmlformats.org/officeDocument/2006/relationships/image" Target="../media/image49.jpeg"/><Relationship Id="rId3" Type="http://schemas.openxmlformats.org/officeDocument/2006/relationships/image" Target="../media/image50.jpeg"/><Relationship Id="rId4" Type="http://schemas.openxmlformats.org/officeDocument/2006/relationships/image" Target="../media/image51.jpeg"/><Relationship Id="rId5" Type="http://schemas.openxmlformats.org/officeDocument/2006/relationships/image" Target="../media/image52.jpeg"/><Relationship Id="rId6" Type="http://schemas.openxmlformats.org/officeDocument/2006/relationships/image" Target="../media/image53.jpeg"/><Relationship Id="rId7" Type="http://schemas.openxmlformats.org/officeDocument/2006/relationships/image" Target="../media/image54.jpeg"/><Relationship Id="rId8" Type="http://schemas.openxmlformats.org/officeDocument/2006/relationships/image" Target="../media/image55.jpeg"/><Relationship Id="rId9" Type="http://schemas.openxmlformats.org/officeDocument/2006/relationships/image" Target="../media/image56.jpeg"/><Relationship Id="rId10" Type="http://schemas.openxmlformats.org/officeDocument/2006/relationships/image" Target="../media/image57.jpeg"/><Relationship Id="rId11" Type="http://schemas.openxmlformats.org/officeDocument/2006/relationships/image" Target="../media/image58.jpeg"/><Relationship Id="rId12" Type="http://schemas.openxmlformats.org/officeDocument/2006/relationships/image" Target="../media/image59.jpeg"/><Relationship Id="rId13" Type="http://schemas.openxmlformats.org/officeDocument/2006/relationships/image" Target="../media/image60.jpeg"/><Relationship Id="rId14" Type="http://schemas.openxmlformats.org/officeDocument/2006/relationships/image" Target="../media/image61.jpeg"/><Relationship Id="rId15" Type="http://schemas.openxmlformats.org/officeDocument/2006/relationships/image" Target="../media/image62.jpeg"/><Relationship Id="rId16" Type="http://schemas.openxmlformats.org/officeDocument/2006/relationships/image" Target="../media/image63.jpeg"/><Relationship Id="rId17" Type="http://schemas.openxmlformats.org/officeDocument/2006/relationships/image" Target="../media/image64.jpeg"/><Relationship Id="rId18" Type="http://schemas.openxmlformats.org/officeDocument/2006/relationships/image" Target="../media/image65.jpeg"/><Relationship Id="rId19" Type="http://schemas.openxmlformats.org/officeDocument/2006/relationships/image" Target="../media/image66.jpeg"/><Relationship Id="rId20" Type="http://schemas.openxmlformats.org/officeDocument/2006/relationships/image" Target="../media/image67.jpeg"/><Relationship Id="rId21" Type="http://schemas.openxmlformats.org/officeDocument/2006/relationships/image" Target="../media/image68.jpeg"/><Relationship Id="rId22" Type="http://schemas.openxmlformats.org/officeDocument/2006/relationships/image" Target="../media/image69.jpeg"/><Relationship Id="rId23" Type="http://schemas.openxmlformats.org/officeDocument/2006/relationships/image" Target="../media/image70.jpeg"/><Relationship Id="rId24" Type="http://schemas.openxmlformats.org/officeDocument/2006/relationships/image" Target="../media/image71.jpeg"/><Relationship Id="rId25" Type="http://schemas.openxmlformats.org/officeDocument/2006/relationships/image" Target="../media/image72.jpeg"/><Relationship Id="rId26" Type="http://schemas.openxmlformats.org/officeDocument/2006/relationships/image" Target="../media/image73.jpeg"/><Relationship Id="rId27" Type="http://schemas.openxmlformats.org/officeDocument/2006/relationships/image" Target="../media/image74.jpeg"/><Relationship Id="rId28" Type="http://schemas.openxmlformats.org/officeDocument/2006/relationships/image" Target="../media/image75.jpeg"/><Relationship Id="rId29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76.jpeg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77.jpe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60"/>
          <p:cNvGrpSpPr/>
          <p:nvPr/>
        </p:nvGrpSpPr>
        <p:grpSpPr>
          <a:xfrm>
            <a:off x="228600" y="76320"/>
            <a:ext cx="8077320" cy="6400800"/>
            <a:chOff x="228600" y="76320"/>
            <a:chExt cx="8077320" cy="6400800"/>
          </a:xfrm>
        </p:grpSpPr>
        <p:grpSp>
          <p:nvGrpSpPr>
            <p:cNvPr id="42" name="Group 62"/>
            <p:cNvGrpSpPr/>
            <p:nvPr/>
          </p:nvGrpSpPr>
          <p:grpSpPr>
            <a:xfrm>
              <a:off x="1038600" y="450000"/>
              <a:ext cx="6744240" cy="6027120"/>
              <a:chOff x="1038600" y="450000"/>
              <a:chExt cx="6744240" cy="6027120"/>
            </a:xfrm>
          </p:grpSpPr>
          <p:grpSp>
            <p:nvGrpSpPr>
              <p:cNvPr id="43" name="Group 9"/>
              <p:cNvGrpSpPr/>
              <p:nvPr/>
            </p:nvGrpSpPr>
            <p:grpSpPr>
              <a:xfrm>
                <a:off x="1110240" y="450000"/>
                <a:ext cx="6672600" cy="897840"/>
                <a:chOff x="1110240" y="450000"/>
                <a:chExt cx="6672600" cy="897840"/>
              </a:xfrm>
            </p:grpSpPr>
            <p:pic>
              <p:nvPicPr>
                <p:cNvPr id="44" name="Picture 2" descr="G:\TRICHO 2ND PAPER\PHOTOS\MEDIA PHOTOS\T-1\PDA\IMG_3158.JPG"/>
                <p:cNvPicPr/>
                <p:nvPr/>
              </p:nvPicPr>
              <p:blipFill>
                <a:blip r:embed="rId1"/>
                <a:stretch/>
              </p:blipFill>
              <p:spPr>
                <a:xfrm>
                  <a:off x="1110240" y="450000"/>
                  <a:ext cx="912960" cy="88740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45" name="Picture 3" descr="G:\TRICHO 2ND PAPER\PHOTOS\MEDIA PHOTOS\T-2\PDA\IMG_3161.JPG"/>
                <p:cNvPicPr/>
                <p:nvPr/>
              </p:nvPicPr>
              <p:blipFill>
                <a:blip r:embed="rId2"/>
                <a:stretch/>
              </p:blipFill>
              <p:spPr>
                <a:xfrm>
                  <a:off x="2091600" y="450000"/>
                  <a:ext cx="914760" cy="89316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46" name="Picture 4" descr="G:\TRICHO 2ND PAPER\PHOTOS\MEDIA PHOTOS\T-3\PDA\IMG_3166.JPG"/>
                <p:cNvPicPr/>
                <p:nvPr/>
              </p:nvPicPr>
              <p:blipFill>
                <a:blip r:embed="rId3"/>
                <a:stretch/>
              </p:blipFill>
              <p:spPr>
                <a:xfrm>
                  <a:off x="3076920" y="457200"/>
                  <a:ext cx="874800" cy="88596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47" name="Picture 5" descr="G:\TRICHO 2ND PAPER\PHOTOS\MEDIA PHOTOS\T-15(A)\PDA\IMG_3168.JPG"/>
                <p:cNvPicPr/>
                <p:nvPr/>
              </p:nvPicPr>
              <p:blipFill>
                <a:blip r:embed="rId4"/>
                <a:stretch/>
              </p:blipFill>
              <p:spPr>
                <a:xfrm>
                  <a:off x="3989880" y="470160"/>
                  <a:ext cx="912960" cy="87336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48" name="Picture 6" descr="G:\TRICHO 2ND PAPER\PHOTOS\MEDIA PHOTOS\T-16\PDA\IMG_3172.JPG"/>
                <p:cNvPicPr/>
                <p:nvPr/>
              </p:nvPicPr>
              <p:blipFill>
                <a:blip r:embed="rId5"/>
                <a:stretch/>
              </p:blipFill>
              <p:spPr>
                <a:xfrm>
                  <a:off x="4973400" y="457200"/>
                  <a:ext cx="912960" cy="89064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49" name="Picture 7" descr="G:\TRICHO 2ND PAPER\PHOTOS\MEDIA PHOTOS\T-22 OR U-1\PDA\IMG_3173.JPG"/>
                <p:cNvPicPr/>
                <p:nvPr/>
              </p:nvPicPr>
              <p:blipFill>
                <a:blip r:embed="rId6"/>
                <a:stretch/>
              </p:blipFill>
              <p:spPr>
                <a:xfrm>
                  <a:off x="5951160" y="457200"/>
                  <a:ext cx="905400" cy="88596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50" name="Picture 8" descr="G:\TRICHO 2ND PAPER\PHOTOS\MEDIA PHOTOS\T-27 OR U-7\PDA\IMG_3177.JPG"/>
                <p:cNvPicPr/>
                <p:nvPr/>
              </p:nvPicPr>
              <p:blipFill>
                <a:blip r:embed="rId7"/>
                <a:stretch/>
              </p:blipFill>
              <p:spPr>
                <a:xfrm>
                  <a:off x="6932880" y="457200"/>
                  <a:ext cx="849960" cy="885960"/>
                </a:xfrm>
                <a:prstGeom prst="rect">
                  <a:avLst/>
                </a:prstGeom>
                <a:ln w="0">
                  <a:noFill/>
                </a:ln>
              </p:spPr>
            </p:pic>
          </p:grpSp>
          <p:grpSp>
            <p:nvGrpSpPr>
              <p:cNvPr id="51" name="Group 17"/>
              <p:cNvGrpSpPr/>
              <p:nvPr/>
            </p:nvGrpSpPr>
            <p:grpSpPr>
              <a:xfrm>
                <a:off x="1110240" y="1360080"/>
                <a:ext cx="6672600" cy="904680"/>
                <a:chOff x="1110240" y="1360080"/>
                <a:chExt cx="6672600" cy="904680"/>
              </a:xfrm>
            </p:grpSpPr>
            <p:pic>
              <p:nvPicPr>
                <p:cNvPr id="52" name="Picture 9" descr="G:\TRICHO 2ND PAPER\PHOTOS\MEDIA PHOTOS\T-1\MEA\T-1.JPG"/>
                <p:cNvPicPr/>
                <p:nvPr/>
              </p:nvPicPr>
              <p:blipFill>
                <a:blip r:embed="rId8"/>
                <a:stretch/>
              </p:blipFill>
              <p:spPr>
                <a:xfrm>
                  <a:off x="1110240" y="1360080"/>
                  <a:ext cx="912960" cy="89532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53" name="Picture 10" descr="G:\TRICHO 2ND PAPER\PHOTOS\MEDIA PHOTOS\T-2\2.MEA\T-2.JPG"/>
                <p:cNvPicPr/>
                <p:nvPr/>
              </p:nvPicPr>
              <p:blipFill>
                <a:blip r:embed="rId9"/>
                <a:stretch/>
              </p:blipFill>
              <p:spPr>
                <a:xfrm>
                  <a:off x="2093400" y="1369080"/>
                  <a:ext cx="912960" cy="89424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54" name="Picture 11" descr="G:\TRICHO 2ND PAPER\PHOTOS\MEDIA PHOTOS\T-3\2.MEA\T-3.JPG"/>
                <p:cNvPicPr/>
                <p:nvPr/>
              </p:nvPicPr>
              <p:blipFill>
                <a:blip r:embed="rId10"/>
                <a:stretch/>
              </p:blipFill>
              <p:spPr>
                <a:xfrm>
                  <a:off x="3076920" y="1369080"/>
                  <a:ext cx="912960" cy="89316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55" name="Picture 12" descr="G:\TRICHO 2ND PAPER\PHOTOS\MEDIA PHOTOS\T-15(A)\2.MEA\T-15.JPG"/>
                <p:cNvPicPr/>
                <p:nvPr/>
              </p:nvPicPr>
              <p:blipFill>
                <a:blip r:embed="rId11"/>
                <a:stretch/>
              </p:blipFill>
              <p:spPr>
                <a:xfrm>
                  <a:off x="4053600" y="1369080"/>
                  <a:ext cx="853920" cy="88596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56" name="Picture 13" descr="G:\TRICHO 2ND PAPER\PHOTOS\MEDIA PHOTOS\T-16\2.MEA\T-16.JPG"/>
                <p:cNvPicPr/>
                <p:nvPr/>
              </p:nvPicPr>
              <p:blipFill>
                <a:blip r:embed="rId12"/>
                <a:stretch/>
              </p:blipFill>
              <p:spPr>
                <a:xfrm>
                  <a:off x="4973400" y="1369080"/>
                  <a:ext cx="912960" cy="88596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57" name="Picture 14" descr="G:\TRICHO 2ND PAPER\PHOTOS\MEDIA PHOTOS\T-22 OR U-1\2.MEA\T-22.JPG"/>
                <p:cNvPicPr/>
                <p:nvPr/>
              </p:nvPicPr>
              <p:blipFill>
                <a:blip r:embed="rId13"/>
                <a:stretch/>
              </p:blipFill>
              <p:spPr>
                <a:xfrm>
                  <a:off x="5943600" y="1369080"/>
                  <a:ext cx="913680" cy="89568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58" name="Picture 15" descr="G:\TRICHO 2ND PAPER\PHOTOS\MEDIA PHOTOS\T-27 OR U-7\2.MEA\T-27.JPG"/>
                <p:cNvPicPr/>
                <p:nvPr/>
              </p:nvPicPr>
              <p:blipFill>
                <a:blip r:embed="rId14"/>
                <a:stretch/>
              </p:blipFill>
              <p:spPr>
                <a:xfrm>
                  <a:off x="6940080" y="1379160"/>
                  <a:ext cx="842760" cy="858600"/>
                </a:xfrm>
                <a:prstGeom prst="rect">
                  <a:avLst/>
                </a:prstGeom>
                <a:ln w="0">
                  <a:noFill/>
                </a:ln>
              </p:spPr>
            </p:pic>
          </p:grpSp>
          <p:grpSp>
            <p:nvGrpSpPr>
              <p:cNvPr id="59" name="Group 25"/>
              <p:cNvGrpSpPr/>
              <p:nvPr/>
            </p:nvGrpSpPr>
            <p:grpSpPr>
              <a:xfrm>
                <a:off x="1110240" y="2277720"/>
                <a:ext cx="6672600" cy="835560"/>
                <a:chOff x="1110240" y="2277720"/>
                <a:chExt cx="6672600" cy="835560"/>
              </a:xfrm>
            </p:grpSpPr>
            <p:pic>
              <p:nvPicPr>
                <p:cNvPr id="60" name="Picture 16" descr="G:\TRICHO 2ND PAPER\PHOTOS\MEDIA PHOTOS\T-1\WA\IMG_3354.JPG"/>
                <p:cNvPicPr/>
                <p:nvPr/>
              </p:nvPicPr>
              <p:blipFill>
                <a:blip r:embed="rId15"/>
                <a:stretch/>
              </p:blipFill>
              <p:spPr>
                <a:xfrm>
                  <a:off x="1110240" y="2282040"/>
                  <a:ext cx="912960" cy="81792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61" name="Picture 18" descr="G:\TRICHO 2ND PAPER\PHOTOS\MEDIA PHOTOS\T-2\3.WA\IMG_3356.JPG"/>
                <p:cNvPicPr/>
                <p:nvPr/>
              </p:nvPicPr>
              <p:blipFill>
                <a:blip r:embed="rId16"/>
                <a:stretch/>
              </p:blipFill>
              <p:spPr>
                <a:xfrm>
                  <a:off x="2093400" y="2282040"/>
                  <a:ext cx="912960" cy="82908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62" name="Picture 19" descr="G:\TRICHO 2ND PAPER\PHOTOS\MEDIA PHOTOS\T-3\3.WA\IMG_3359.JPG"/>
                <p:cNvPicPr/>
                <p:nvPr/>
              </p:nvPicPr>
              <p:blipFill>
                <a:blip r:embed="rId17"/>
                <a:stretch/>
              </p:blipFill>
              <p:spPr>
                <a:xfrm flipH="1">
                  <a:off x="3076920" y="2282040"/>
                  <a:ext cx="912960" cy="81792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63" name="Picture 20" descr="G:\TRICHO 2ND PAPER\PHOTOS\MEDIA PHOTOS\T-15(A)\3.WA\IMG_3361.JPG"/>
                <p:cNvPicPr/>
                <p:nvPr/>
              </p:nvPicPr>
              <p:blipFill>
                <a:blip r:embed="rId18"/>
                <a:stretch/>
              </p:blipFill>
              <p:spPr>
                <a:xfrm>
                  <a:off x="4070880" y="2282040"/>
                  <a:ext cx="831960" cy="83124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64" name="Picture 21" descr="G:\TRICHO 2ND PAPER\PHOTOS\MEDIA PHOTOS\T-16\3.WA\IMG_3365.JPG"/>
                <p:cNvPicPr/>
                <p:nvPr/>
              </p:nvPicPr>
              <p:blipFill>
                <a:blip r:embed="rId19"/>
                <a:stretch/>
              </p:blipFill>
              <p:spPr>
                <a:xfrm>
                  <a:off x="4964400" y="2282040"/>
                  <a:ext cx="921960" cy="81792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65" name="Picture 22" descr="G:\TRICHO 2ND PAPER\PHOTOS\MEDIA PHOTOS\T-22 OR U-1\3.WA\IMG_3371.JPG"/>
                <p:cNvPicPr/>
                <p:nvPr/>
              </p:nvPicPr>
              <p:blipFill>
                <a:blip r:embed="rId20"/>
                <a:stretch/>
              </p:blipFill>
              <p:spPr>
                <a:xfrm>
                  <a:off x="5956560" y="2279520"/>
                  <a:ext cx="912960" cy="81864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66" name="Picture 23" descr="G:\TRICHO 2ND PAPER\PHOTOS\MEDIA PHOTOS\T-27 OR U-7\3.WA\IMG_3368.JPG"/>
                <p:cNvPicPr/>
                <p:nvPr/>
              </p:nvPicPr>
              <p:blipFill>
                <a:blip r:embed="rId21"/>
                <a:stretch/>
              </p:blipFill>
              <p:spPr>
                <a:xfrm>
                  <a:off x="6940080" y="2277720"/>
                  <a:ext cx="842760" cy="822600"/>
                </a:xfrm>
                <a:prstGeom prst="rect">
                  <a:avLst/>
                </a:prstGeom>
                <a:ln w="0">
                  <a:noFill/>
                </a:ln>
              </p:spPr>
            </p:pic>
          </p:grpSp>
          <p:grpSp>
            <p:nvGrpSpPr>
              <p:cNvPr id="67" name="Group 33"/>
              <p:cNvGrpSpPr/>
              <p:nvPr/>
            </p:nvGrpSpPr>
            <p:grpSpPr>
              <a:xfrm>
                <a:off x="1087200" y="3124800"/>
                <a:ext cx="6672600" cy="828720"/>
                <a:chOff x="1087200" y="3124800"/>
                <a:chExt cx="6672600" cy="828720"/>
              </a:xfrm>
            </p:grpSpPr>
            <p:pic>
              <p:nvPicPr>
                <p:cNvPr id="68" name="Picture 24" descr="G:\TRICHO 2ND PAPER\PHOTOS\MEDIA PHOTOS\T-1\SYN PDA\T-1.JPG"/>
                <p:cNvPicPr/>
                <p:nvPr/>
              </p:nvPicPr>
              <p:blipFill>
                <a:blip r:embed="rId22"/>
                <a:stretch/>
              </p:blipFill>
              <p:spPr>
                <a:xfrm>
                  <a:off x="1087200" y="3124800"/>
                  <a:ext cx="912960" cy="81828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69" name="Picture 25" descr="G:\TRICHO 2ND PAPER\PHOTOS\MEDIA PHOTOS\T-2\4.SYN PDA\T-2.JPG"/>
                <p:cNvPicPr/>
                <p:nvPr/>
              </p:nvPicPr>
              <p:blipFill>
                <a:blip r:embed="rId23"/>
                <a:stretch/>
              </p:blipFill>
              <p:spPr>
                <a:xfrm>
                  <a:off x="2070360" y="3124800"/>
                  <a:ext cx="912960" cy="81792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70" name="Picture 26" descr="G:\TRICHO 2ND PAPER\PHOTOS\MEDIA PHOTOS\T-3\4.SYN PDA\T-3.JPG"/>
                <p:cNvPicPr/>
                <p:nvPr/>
              </p:nvPicPr>
              <p:blipFill>
                <a:blip r:embed="rId24"/>
                <a:stretch/>
              </p:blipFill>
              <p:spPr>
                <a:xfrm>
                  <a:off x="3053880" y="3124800"/>
                  <a:ext cx="912960" cy="81792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71" name="Picture 27" descr="G:\TRICHO 2ND PAPER\PHOTOS\MEDIA PHOTOS\T-15(A)\4.SYN PDA\T-15.JPG"/>
                <p:cNvPicPr/>
                <p:nvPr/>
              </p:nvPicPr>
              <p:blipFill>
                <a:blip r:embed="rId25"/>
                <a:stretch/>
              </p:blipFill>
              <p:spPr>
                <a:xfrm>
                  <a:off x="4037040" y="3124800"/>
                  <a:ext cx="842760" cy="81792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72" name="Picture 28" descr="G:\TRICHO 2ND PAPER\PHOTOS\MEDIA PHOTOS\T-16\4.SYN PDA\T-16.JPG"/>
                <p:cNvPicPr/>
                <p:nvPr/>
              </p:nvPicPr>
              <p:blipFill>
                <a:blip r:embed="rId26"/>
                <a:stretch/>
              </p:blipFill>
              <p:spPr>
                <a:xfrm>
                  <a:off x="4950360" y="3124800"/>
                  <a:ext cx="912960" cy="81792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73" name="Picture 29" descr="G:\TRICHO 2ND PAPER\PHOTOS\MEDIA PHOTOS\T-22 OR U-1\4.SYN PDA\T-22.JPG"/>
                <p:cNvPicPr/>
                <p:nvPr/>
              </p:nvPicPr>
              <p:blipFill>
                <a:blip r:embed="rId27"/>
                <a:stretch/>
              </p:blipFill>
              <p:spPr>
                <a:xfrm>
                  <a:off x="5933520" y="3124800"/>
                  <a:ext cx="909000" cy="82872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74" name="Picture 30" descr="G:\TRICHO 2ND PAPER\PHOTOS\MEDIA PHOTOS\T-27 OR U-7\4.SYN PDA\T-27.JPG"/>
                <p:cNvPicPr/>
                <p:nvPr/>
              </p:nvPicPr>
              <p:blipFill>
                <a:blip r:embed="rId28"/>
                <a:stretch/>
              </p:blipFill>
              <p:spPr>
                <a:xfrm>
                  <a:off x="6917040" y="3124800"/>
                  <a:ext cx="842760" cy="817920"/>
                </a:xfrm>
                <a:prstGeom prst="rect">
                  <a:avLst/>
                </a:prstGeom>
                <a:ln w="0">
                  <a:noFill/>
                </a:ln>
              </p:spPr>
            </p:pic>
          </p:grpSp>
          <p:grpSp>
            <p:nvGrpSpPr>
              <p:cNvPr id="75" name="Group 41"/>
              <p:cNvGrpSpPr/>
              <p:nvPr/>
            </p:nvGrpSpPr>
            <p:grpSpPr>
              <a:xfrm>
                <a:off x="1075680" y="3960720"/>
                <a:ext cx="6696720" cy="860400"/>
                <a:chOff x="1075680" y="3960720"/>
                <a:chExt cx="6696720" cy="860400"/>
              </a:xfrm>
            </p:grpSpPr>
            <p:pic>
              <p:nvPicPr>
                <p:cNvPr id="76" name="Picture 31" descr="G:\TRICHO 2ND PAPER\PHOTOS\MEDIA PHOTOS\T-1\OMA\IMG_3376.JPG"/>
                <p:cNvPicPr/>
                <p:nvPr/>
              </p:nvPicPr>
              <p:blipFill>
                <a:blip r:embed="rId29"/>
                <a:stretch/>
              </p:blipFill>
              <p:spPr>
                <a:xfrm>
                  <a:off x="1075680" y="3960720"/>
                  <a:ext cx="899640" cy="80388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77" name="Picture 32" descr="G:\TRICHO 2ND PAPER\PHOTOS\MEDIA PHOTOS\T-2\5.OMA\IMG_3381.JPG"/>
                <p:cNvPicPr/>
                <p:nvPr/>
              </p:nvPicPr>
              <p:blipFill>
                <a:blip r:embed="rId30"/>
                <a:stretch/>
              </p:blipFill>
              <p:spPr>
                <a:xfrm>
                  <a:off x="2031480" y="3960720"/>
                  <a:ext cx="903240" cy="81792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78" name="Picture 33" descr="G:\TRICHO 2ND PAPER\PHOTOS\MEDIA PHOTOS\T-3\5.OMA\IMG_3387.JPG"/>
                <p:cNvPicPr/>
                <p:nvPr/>
              </p:nvPicPr>
              <p:blipFill>
                <a:blip r:embed="rId31"/>
                <a:stretch/>
              </p:blipFill>
              <p:spPr>
                <a:xfrm>
                  <a:off x="3017880" y="3960720"/>
                  <a:ext cx="912960" cy="81828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79" name="Picture 34" descr="G:\TRICHO 2ND PAPER\PHOTOS\MEDIA PHOTOS\T-15(A)\5.OMA\IMG_3393.JPG"/>
                <p:cNvPicPr/>
                <p:nvPr/>
              </p:nvPicPr>
              <p:blipFill>
                <a:blip r:embed="rId32"/>
                <a:stretch/>
              </p:blipFill>
              <p:spPr>
                <a:xfrm>
                  <a:off x="3984120" y="3960720"/>
                  <a:ext cx="851400" cy="82152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80" name="Picture 35" descr="G:\TRICHO 2ND PAPER\PHOTOS\MEDIA PHOTOS\T-16\5.OMA\IMG_3401.JPG"/>
                <p:cNvPicPr/>
                <p:nvPr/>
              </p:nvPicPr>
              <p:blipFill>
                <a:blip r:embed="rId33"/>
                <a:stretch/>
              </p:blipFill>
              <p:spPr>
                <a:xfrm>
                  <a:off x="4901400" y="3960720"/>
                  <a:ext cx="931320" cy="81792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81" name="Picture 36" descr="G:\TRICHO 2ND PAPER\PHOTOS\MEDIA PHOTOS\T-22 OR U-1\5.OMA\IMG_3406.JPG"/>
                <p:cNvPicPr/>
                <p:nvPr/>
              </p:nvPicPr>
              <p:blipFill>
                <a:blip r:embed="rId34"/>
                <a:stretch/>
              </p:blipFill>
              <p:spPr>
                <a:xfrm>
                  <a:off x="5904360" y="3997800"/>
                  <a:ext cx="925920" cy="82332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82" name="Picture 37" descr="G:\TRICHO 2ND PAPER\PHOTOS\MEDIA PHOTOS\T-27 OR U-7\5.OMA\IMG_3413.JPG"/>
                <p:cNvPicPr/>
                <p:nvPr/>
              </p:nvPicPr>
              <p:blipFill>
                <a:blip r:embed="rId35"/>
                <a:stretch/>
              </p:blipFill>
              <p:spPr>
                <a:xfrm>
                  <a:off x="6886440" y="3960720"/>
                  <a:ext cx="885960" cy="834120"/>
                </a:xfrm>
                <a:prstGeom prst="rect">
                  <a:avLst/>
                </a:prstGeom>
                <a:ln w="0">
                  <a:noFill/>
                </a:ln>
              </p:spPr>
            </p:pic>
          </p:grpSp>
          <p:grpSp>
            <p:nvGrpSpPr>
              <p:cNvPr id="83" name="Group 51"/>
              <p:cNvGrpSpPr/>
              <p:nvPr/>
            </p:nvGrpSpPr>
            <p:grpSpPr>
              <a:xfrm>
                <a:off x="1076040" y="4812120"/>
                <a:ext cx="6683400" cy="817920"/>
                <a:chOff x="1076040" y="4812120"/>
                <a:chExt cx="6683400" cy="817920"/>
              </a:xfrm>
            </p:grpSpPr>
            <p:pic>
              <p:nvPicPr>
                <p:cNvPr id="84" name="Picture 38" descr="G:\TRICHO 2ND PAPER\PHOTOS\MEDIA PHOTOS\T-2\6.NA\IMG_3342.JPG"/>
                <p:cNvPicPr/>
                <p:nvPr/>
              </p:nvPicPr>
              <p:blipFill>
                <a:blip r:embed="rId36"/>
                <a:stretch/>
              </p:blipFill>
              <p:spPr>
                <a:xfrm>
                  <a:off x="2035080" y="4812120"/>
                  <a:ext cx="914760" cy="81792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85" name="Picture 39" descr="G:\TRICHO 2ND PAPER\PHOTOS\MEDIA PHOTOS\T-3\6.NA\IMG_3347.JPG"/>
                <p:cNvPicPr/>
                <p:nvPr/>
              </p:nvPicPr>
              <p:blipFill>
                <a:blip r:embed="rId37"/>
                <a:stretch/>
              </p:blipFill>
              <p:spPr>
                <a:xfrm>
                  <a:off x="3020400" y="4825080"/>
                  <a:ext cx="914760" cy="80496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86" name="Picture 40" descr="G:\TRICHO 2ND PAPER\PHOTOS\MEDIA PHOTOS\T-15(A)\6.NA\IMG_3352.JPG"/>
                <p:cNvPicPr/>
                <p:nvPr/>
              </p:nvPicPr>
              <p:blipFill>
                <a:blip r:embed="rId38"/>
                <a:stretch/>
              </p:blipFill>
              <p:spPr>
                <a:xfrm>
                  <a:off x="3987720" y="4812120"/>
                  <a:ext cx="899280" cy="81576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87" name="Picture 41" descr="G:\TRICHO 2ND PAPER\PHOTOS\MEDIA PHOTOS\T-16\6.NA\IMG_3348.JPG"/>
                <p:cNvPicPr/>
                <p:nvPr/>
              </p:nvPicPr>
              <p:blipFill>
                <a:blip r:embed="rId39"/>
                <a:stretch/>
              </p:blipFill>
              <p:spPr>
                <a:xfrm>
                  <a:off x="4957560" y="4813920"/>
                  <a:ext cx="914760" cy="81612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88" name="Picture 40" descr="G:\TRICHO 2ND PAPER\PHOTOS\MEDIA PHOTOS\T-15(A)\6.NA\IMG_3352.JPG"/>
                <p:cNvPicPr/>
                <p:nvPr/>
              </p:nvPicPr>
              <p:blipFill>
                <a:blip r:embed="rId40"/>
                <a:stretch/>
              </p:blipFill>
              <p:spPr>
                <a:xfrm>
                  <a:off x="6914880" y="4812120"/>
                  <a:ext cx="844560" cy="81576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89" name="Picture 41" descr="G:\TRICHO 2ND PAPER\PHOTOS\MEDIA PHOTOS\T-16\6.NA\IMG_3348.JPG"/>
                <p:cNvPicPr/>
                <p:nvPr/>
              </p:nvPicPr>
              <p:blipFill>
                <a:blip r:embed="rId41"/>
                <a:stretch/>
              </p:blipFill>
              <p:spPr>
                <a:xfrm>
                  <a:off x="1076040" y="4813920"/>
                  <a:ext cx="914760" cy="81612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90" name="Picture 39" descr="G:\TRICHO 2ND PAPER\PHOTOS\MEDIA PHOTOS\T-3\6.NA\IMG_3347.JPG"/>
                <p:cNvPicPr/>
                <p:nvPr/>
              </p:nvPicPr>
              <p:blipFill>
                <a:blip r:embed="rId42"/>
                <a:stretch/>
              </p:blipFill>
              <p:spPr>
                <a:xfrm>
                  <a:off x="5942520" y="4824360"/>
                  <a:ext cx="914760" cy="804960"/>
                </a:xfrm>
                <a:prstGeom prst="rect">
                  <a:avLst/>
                </a:prstGeom>
                <a:ln w="0">
                  <a:noFill/>
                </a:ln>
              </p:spPr>
            </p:pic>
          </p:grpSp>
          <p:grpSp>
            <p:nvGrpSpPr>
              <p:cNvPr id="91" name="Group 61"/>
              <p:cNvGrpSpPr/>
              <p:nvPr/>
            </p:nvGrpSpPr>
            <p:grpSpPr>
              <a:xfrm>
                <a:off x="1038600" y="5644440"/>
                <a:ext cx="6725880" cy="832680"/>
                <a:chOff x="1038600" y="5644440"/>
                <a:chExt cx="6725880" cy="832680"/>
              </a:xfrm>
            </p:grpSpPr>
            <p:pic>
              <p:nvPicPr>
                <p:cNvPr id="92" name="Picture 42" descr="G:\TRICHO 2ND PAPER\PHOTOS\MEDIA PHOTOS\T-1\RLEA\IMG_3373.JPG"/>
                <p:cNvPicPr/>
                <p:nvPr/>
              </p:nvPicPr>
              <p:blipFill>
                <a:blip r:embed="rId43"/>
                <a:stretch/>
              </p:blipFill>
              <p:spPr>
                <a:xfrm>
                  <a:off x="1038600" y="5644440"/>
                  <a:ext cx="984960" cy="80352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93" name="Picture 43" descr="G:\TRICHO 2ND PAPER\PHOTOS\MEDIA PHOTOS\T-2\7.RLEA\IMG_3379.JPG"/>
                <p:cNvPicPr/>
                <p:nvPr/>
              </p:nvPicPr>
              <p:blipFill>
                <a:blip r:embed="rId44"/>
                <a:stretch/>
              </p:blipFill>
              <p:spPr>
                <a:xfrm>
                  <a:off x="2066760" y="5655960"/>
                  <a:ext cx="869400" cy="81468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94" name="Picture 44" descr="G:\TRICHO 2ND PAPER\PHOTOS\MEDIA PHOTOS\T-3\7.RLEA\IMG_3384.JPG"/>
                <p:cNvPicPr/>
                <p:nvPr/>
              </p:nvPicPr>
              <p:blipFill>
                <a:blip r:embed="rId45"/>
                <a:stretch/>
              </p:blipFill>
              <p:spPr>
                <a:xfrm>
                  <a:off x="3006720" y="5659200"/>
                  <a:ext cx="956520" cy="81792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95" name="Picture 45" descr="G:\TRICHO 2ND PAPER\PHOTOS\MEDIA PHOTOS\T-15(A)\7.RLEA\IMG_3390.JPG"/>
                <p:cNvPicPr/>
                <p:nvPr/>
              </p:nvPicPr>
              <p:blipFill>
                <a:blip r:embed="rId46"/>
                <a:stretch/>
              </p:blipFill>
              <p:spPr>
                <a:xfrm>
                  <a:off x="3990240" y="5656680"/>
                  <a:ext cx="912960" cy="81720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96" name="Picture 46" descr="G:\TRICHO 2ND PAPER\PHOTOS\MEDIA PHOTOS\T-16\7.RLEA\IMG_3398.JPG"/>
                <p:cNvPicPr/>
                <p:nvPr/>
              </p:nvPicPr>
              <p:blipFill>
                <a:blip r:embed="rId47"/>
                <a:stretch/>
              </p:blipFill>
              <p:spPr>
                <a:xfrm>
                  <a:off x="4973400" y="5655240"/>
                  <a:ext cx="912960" cy="81792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97" name="Picture 47" descr="G:\TRICHO 2ND PAPER\PHOTOS\MEDIA PHOTOS\T-22 OR U-1\7.RLEA\IMG_3404.JPG"/>
                <p:cNvPicPr/>
                <p:nvPr/>
              </p:nvPicPr>
              <p:blipFill>
                <a:blip r:embed="rId48"/>
                <a:stretch/>
              </p:blipFill>
              <p:spPr>
                <a:xfrm>
                  <a:off x="5956920" y="5653440"/>
                  <a:ext cx="902880" cy="80748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98" name="Picture 48" descr="G:\TRICHO 2ND PAPER\PHOTOS\MEDIA PHOTOS\T-27 OR U-7\7.RLEA\IMG_3408.JPG"/>
                <p:cNvPicPr/>
                <p:nvPr/>
              </p:nvPicPr>
              <p:blipFill>
                <a:blip r:embed="rId49"/>
                <a:stretch/>
              </p:blipFill>
              <p:spPr>
                <a:xfrm>
                  <a:off x="6912000" y="5648760"/>
                  <a:ext cx="852480" cy="817920"/>
                </a:xfrm>
                <a:prstGeom prst="rect">
                  <a:avLst/>
                </a:prstGeom>
                <a:ln w="0">
                  <a:noFill/>
                </a:ln>
              </p:spPr>
            </p:pic>
          </p:grpSp>
        </p:grpSp>
        <p:sp>
          <p:nvSpPr>
            <p:cNvPr id="99" name="TextBox 58"/>
            <p:cNvSpPr/>
            <p:nvPr/>
          </p:nvSpPr>
          <p:spPr>
            <a:xfrm>
              <a:off x="304560" y="76320"/>
              <a:ext cx="8001360" cy="1952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IN" sz="1600" spc="-1" strike="noStrike">
                  <a:solidFill>
                    <a:srgbClr val="00b050"/>
                  </a:solidFill>
                  <a:latin typeface="Times New Roman"/>
                  <a:ea typeface="Times New Roman"/>
                </a:rPr>
                <a:t>                 </a:t>
              </a:r>
              <a:r>
                <a:rPr b="1" lang="en-IN" sz="1600" spc="-1" strike="noStrike">
                  <a:solidFill>
                    <a:srgbClr val="00b050"/>
                  </a:solidFill>
                  <a:latin typeface="Times New Roman"/>
                  <a:ea typeface="Times New Roman"/>
                </a:rPr>
                <a:t>CRRIT-1    CRRIT-2   CRRIT-3   CRRIT-15   CRRIT-16  CRRIT-22 CRRIT-27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0" name="TextBox 59"/>
            <p:cNvSpPr/>
            <p:nvPr/>
          </p:nvSpPr>
          <p:spPr>
            <a:xfrm>
              <a:off x="228600" y="511920"/>
              <a:ext cx="954000" cy="5887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IN" sz="2000" spc="-1" strike="noStrike">
                  <a:solidFill>
                    <a:srgbClr val="c00000"/>
                  </a:solidFill>
                  <a:latin typeface="Times New Roman"/>
                  <a:ea typeface="Times New Roman"/>
                </a:rPr>
                <a:t>   </a:t>
              </a:r>
              <a:r>
                <a:rPr b="1" lang="en-IN" sz="2000" spc="-1" strike="noStrike">
                  <a:solidFill>
                    <a:srgbClr val="c00000"/>
                  </a:solidFill>
                  <a:latin typeface="Times New Roman"/>
                  <a:ea typeface="Times New Roman"/>
                </a:rPr>
                <a:t>PDA</a:t>
              </a:r>
              <a:endParaRPr b="0" lang="en-US" sz="2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IN" sz="2000" spc="-1" strike="noStrike">
                  <a:solidFill>
                    <a:srgbClr val="c00000"/>
                  </a:solidFill>
                  <a:latin typeface="Times New Roman"/>
                  <a:ea typeface="Times New Roman"/>
                </a:rPr>
                <a:t>  </a:t>
              </a:r>
              <a:r>
                <a:rPr b="1" lang="en-IN" sz="2000" spc="-1" strike="noStrike">
                  <a:solidFill>
                    <a:srgbClr val="c00000"/>
                  </a:solidFill>
                  <a:latin typeface="Times New Roman"/>
                  <a:ea typeface="Times New Roman"/>
                </a:rPr>
                <a:t>MEA</a:t>
              </a:r>
              <a:endParaRPr b="0" lang="en-US" sz="2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IN" sz="2000" spc="-1" strike="noStrike">
                  <a:solidFill>
                    <a:srgbClr val="c00000"/>
                  </a:solidFill>
                  <a:latin typeface="Times New Roman"/>
                  <a:ea typeface="Times New Roman"/>
                </a:rPr>
                <a:t>   </a:t>
              </a:r>
              <a:r>
                <a:rPr b="1" lang="en-IN" sz="2000" spc="-1" strike="noStrike">
                  <a:solidFill>
                    <a:srgbClr val="c00000"/>
                  </a:solidFill>
                  <a:latin typeface="Times New Roman"/>
                  <a:ea typeface="Times New Roman"/>
                </a:rPr>
                <a:t>WA</a:t>
              </a:r>
              <a:endParaRPr b="0" lang="en-US" sz="2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IN" sz="2000" spc="-1" strike="noStrike">
                  <a:solidFill>
                    <a:srgbClr val="c00000"/>
                  </a:solidFill>
                  <a:latin typeface="Times New Roman"/>
                  <a:ea typeface="Times New Roman"/>
                </a:rPr>
                <a:t>   </a:t>
              </a:r>
              <a:endParaRPr b="0" lang="en-US" sz="2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IN" sz="2000" spc="-1" strike="noStrike">
                  <a:solidFill>
                    <a:srgbClr val="c00000"/>
                  </a:solidFill>
                  <a:latin typeface="Times New Roman"/>
                  <a:ea typeface="Times New Roman"/>
                </a:rPr>
                <a:t>SYN PDA</a:t>
              </a:r>
              <a:endParaRPr b="0" lang="en-US" sz="2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IN" sz="2000" spc="-1" strike="noStrike">
                  <a:solidFill>
                    <a:srgbClr val="c00000"/>
                  </a:solidFill>
                  <a:latin typeface="Times New Roman"/>
                  <a:ea typeface="Times New Roman"/>
                </a:rPr>
                <a:t>OMA</a:t>
              </a:r>
              <a:endParaRPr b="0" lang="en-US" sz="2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IN" sz="2000" spc="-1" strike="noStrike">
                  <a:solidFill>
                    <a:srgbClr val="c00000"/>
                  </a:solidFill>
                  <a:latin typeface="Times New Roman"/>
                  <a:ea typeface="Times New Roman"/>
                </a:rPr>
                <a:t>   </a:t>
              </a:r>
              <a:r>
                <a:rPr b="1" lang="en-IN" sz="2000" spc="-1" strike="noStrike">
                  <a:solidFill>
                    <a:srgbClr val="c00000"/>
                  </a:solidFill>
                  <a:latin typeface="Times New Roman"/>
                  <a:ea typeface="Times New Roman"/>
                </a:rPr>
                <a:t>NA</a:t>
              </a:r>
              <a:endParaRPr b="0" lang="en-US" sz="2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IN" sz="2000" spc="-1" strike="noStrike">
                  <a:solidFill>
                    <a:srgbClr val="c00000"/>
                  </a:solidFill>
                  <a:latin typeface="Times New Roman"/>
                  <a:ea typeface="Times New Roman"/>
                </a:rPr>
                <a:t>RLEA</a:t>
              </a:r>
              <a:endParaRPr b="0" lang="en-US" sz="2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01" name="TextBox 10"/>
          <p:cNvSpPr/>
          <p:nvPr/>
        </p:nvSpPr>
        <p:spPr>
          <a:xfrm>
            <a:off x="0" y="6469200"/>
            <a:ext cx="9144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IN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-1 F-1: Morphological growth pattern(5days after inoculation) on Various medium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2" name="Group 33"/>
          <p:cNvGrpSpPr/>
          <p:nvPr/>
        </p:nvGrpSpPr>
        <p:grpSpPr>
          <a:xfrm>
            <a:off x="0" y="380880"/>
            <a:ext cx="9144000" cy="9333720"/>
            <a:chOff x="0" y="380880"/>
            <a:chExt cx="9144000" cy="9333720"/>
          </a:xfrm>
        </p:grpSpPr>
        <p:grpSp>
          <p:nvGrpSpPr>
            <p:cNvPr id="103" name="Group 46"/>
            <p:cNvGrpSpPr/>
            <p:nvPr/>
          </p:nvGrpSpPr>
          <p:grpSpPr>
            <a:xfrm>
              <a:off x="0" y="380880"/>
              <a:ext cx="9144000" cy="9333720"/>
              <a:chOff x="0" y="380880"/>
              <a:chExt cx="9144000" cy="9333720"/>
            </a:xfrm>
          </p:grpSpPr>
          <p:pic>
            <p:nvPicPr>
              <p:cNvPr id="104" name="Picture 2" descr="D:\HSWAIN\latest\ac to sir\dual culture\T5\T5+RS.jpg"/>
              <p:cNvPicPr/>
              <p:nvPr/>
            </p:nvPicPr>
            <p:blipFill>
              <a:blip r:embed="rId1"/>
              <a:stretch/>
            </p:blipFill>
            <p:spPr>
              <a:xfrm>
                <a:off x="1741320" y="838080"/>
                <a:ext cx="1530360" cy="7430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05" name="Picture 2" descr="G:\TRICHO 2ND PAPER\PHOTOS\DUAL CULTURE PHOTOS\T-1\T-1+SO.JPG"/>
              <p:cNvPicPr/>
              <p:nvPr/>
            </p:nvPicPr>
            <p:blipFill>
              <a:blip r:embed="rId2"/>
              <a:stretch/>
            </p:blipFill>
            <p:spPr>
              <a:xfrm>
                <a:off x="3319920" y="852480"/>
                <a:ext cx="1507680" cy="71568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06" name="Picture 4" descr="D:\HSWAIN\latest\ac to sir\dual culture\T1\T1+SRCHPF.jpg"/>
              <p:cNvPicPr/>
              <p:nvPr/>
            </p:nvPicPr>
            <p:blipFill>
              <a:blip r:embed="rId3"/>
              <a:stretch/>
            </p:blipFill>
            <p:spPr>
              <a:xfrm>
                <a:off x="4882680" y="837720"/>
                <a:ext cx="1587240" cy="73728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07" name="Picture 3" descr="G:\TRICHO 2ND PAPER\PHOTOS\DUAL CULTURE PHOTOS\T-1\T-1+SD.JPG"/>
              <p:cNvPicPr/>
              <p:nvPr/>
            </p:nvPicPr>
            <p:blipFill>
              <a:blip r:embed="rId4"/>
              <a:stretch/>
            </p:blipFill>
            <p:spPr>
              <a:xfrm>
                <a:off x="6556680" y="837720"/>
                <a:ext cx="1555560" cy="74628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08" name="Picture 4" descr="G:\TRICHO 2ND PAPER\PHOTOS\DUAL CULTURE PHOTOS\T-2\T-2+RS.JPG"/>
              <p:cNvPicPr/>
              <p:nvPr/>
            </p:nvPicPr>
            <p:blipFill>
              <a:blip r:embed="rId5"/>
              <a:stretch/>
            </p:blipFill>
            <p:spPr>
              <a:xfrm>
                <a:off x="1716120" y="1639440"/>
                <a:ext cx="1548360" cy="74088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09" name="Picture 5" descr="G:\TRICHO 2ND PAPER\PHOTOS\DUAL CULTURE PHOTOS\T-2\T-2+SO.JPG"/>
              <p:cNvPicPr/>
              <p:nvPr/>
            </p:nvPicPr>
            <p:blipFill>
              <a:blip r:embed="rId6"/>
              <a:stretch/>
            </p:blipFill>
            <p:spPr>
              <a:xfrm>
                <a:off x="3326400" y="1624680"/>
                <a:ext cx="1485000" cy="7693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10" name="Picture 7" descr="D:\HSWAIN\latest\ac to sir\dual culture\T2\T2+SRCHP.JPG"/>
              <p:cNvPicPr/>
              <p:nvPr/>
            </p:nvPicPr>
            <p:blipFill>
              <a:blip r:embed="rId7"/>
              <a:stretch/>
            </p:blipFill>
            <p:spPr>
              <a:xfrm>
                <a:off x="4882320" y="1618560"/>
                <a:ext cx="1555920" cy="7952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11" name="Picture 6" descr="G:\TRICHO 2ND PAPER\PHOTOS\DUAL CULTURE PHOTOS\T-2\T-2+SD.JPG"/>
              <p:cNvPicPr/>
              <p:nvPr/>
            </p:nvPicPr>
            <p:blipFill>
              <a:blip r:embed="rId8"/>
              <a:stretch/>
            </p:blipFill>
            <p:spPr>
              <a:xfrm>
                <a:off x="6556320" y="1633320"/>
                <a:ext cx="1555560" cy="7952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12" name="Picture 7" descr="G:\TRICHO 2ND PAPER\PHOTOS\DUAL CULTURE PHOTOS\T-3\T-3+RS.JPG"/>
              <p:cNvPicPr/>
              <p:nvPr/>
            </p:nvPicPr>
            <p:blipFill>
              <a:blip r:embed="rId9"/>
              <a:stretch/>
            </p:blipFill>
            <p:spPr>
              <a:xfrm>
                <a:off x="1716120" y="2428560"/>
                <a:ext cx="1555560" cy="7621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13" name="Picture 9" descr="D:\HSWAIN\latest\ac to sir\dual culture\T3\T3+SO.jpg"/>
              <p:cNvPicPr/>
              <p:nvPr/>
            </p:nvPicPr>
            <p:blipFill>
              <a:blip r:embed="rId10"/>
              <a:stretch/>
            </p:blipFill>
            <p:spPr>
              <a:xfrm>
                <a:off x="3310560" y="2436120"/>
                <a:ext cx="1517040" cy="7729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14" name="Picture 10" descr="D:\HSWAIN\latest\ac to sir\dual culture\T13\T13+SRCHP.jpg"/>
              <p:cNvPicPr/>
              <p:nvPr/>
            </p:nvPicPr>
            <p:blipFill>
              <a:blip r:embed="rId11"/>
              <a:stretch/>
            </p:blipFill>
            <p:spPr>
              <a:xfrm>
                <a:off x="4888080" y="2443320"/>
                <a:ext cx="1581840" cy="7455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15" name="Picture 8" descr="G:\TRICHO 2ND PAPER\PHOTOS\DUAL CULTURE PHOTOS\T-3\T-3+SD.JPG"/>
              <p:cNvPicPr/>
              <p:nvPr/>
            </p:nvPicPr>
            <p:blipFill>
              <a:blip r:embed="rId12"/>
              <a:stretch/>
            </p:blipFill>
            <p:spPr>
              <a:xfrm>
                <a:off x="6556680" y="2463120"/>
                <a:ext cx="1557000" cy="76068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16" name="Picture 9" descr="G:\TRICHO 2ND PAPER\PHOTOS\DUAL CULTURE PHOTOS\T-15\T-15+RS.JPG"/>
              <p:cNvPicPr/>
              <p:nvPr/>
            </p:nvPicPr>
            <p:blipFill>
              <a:blip r:embed="rId13"/>
              <a:stretch/>
            </p:blipFill>
            <p:spPr>
              <a:xfrm>
                <a:off x="1716120" y="3238560"/>
                <a:ext cx="1555560" cy="78228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17" name="Picture 10" descr="G:\TRICHO 2ND PAPER\PHOTOS\DUAL CULTURE PHOTOS\T-15\T-15+SO.JPG"/>
              <p:cNvPicPr/>
              <p:nvPr/>
            </p:nvPicPr>
            <p:blipFill>
              <a:blip r:embed="rId14"/>
              <a:stretch/>
            </p:blipFill>
            <p:spPr>
              <a:xfrm>
                <a:off x="3326400" y="3256920"/>
                <a:ext cx="1501200" cy="7621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18" name="Picture 11" descr="G:\TRICHO 2ND PAPER\PHOTOS\DUAL CULTURE PHOTOS\T-15\T-15+SR.JPG"/>
              <p:cNvPicPr/>
              <p:nvPr/>
            </p:nvPicPr>
            <p:blipFill>
              <a:blip r:embed="rId15"/>
              <a:stretch/>
            </p:blipFill>
            <p:spPr>
              <a:xfrm>
                <a:off x="4884840" y="3256920"/>
                <a:ext cx="1582560" cy="77508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19" name="Picture 12" descr="G:\TRICHO 2ND PAPER\PHOTOS\DUAL CULTURE PHOTOS\T-15\T-15+SD.JPG"/>
              <p:cNvPicPr/>
              <p:nvPr/>
            </p:nvPicPr>
            <p:blipFill>
              <a:blip r:embed="rId16"/>
              <a:stretch/>
            </p:blipFill>
            <p:spPr>
              <a:xfrm>
                <a:off x="6556320" y="3274200"/>
                <a:ext cx="1596960" cy="7952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20" name="Picture 13" descr="G:\TRICHO 2ND PAPER\PHOTOS\DUAL CULTURE PHOTOS\T-16\T-16+RS.JPG"/>
              <p:cNvPicPr/>
              <p:nvPr/>
            </p:nvPicPr>
            <p:blipFill>
              <a:blip r:embed="rId17"/>
              <a:stretch/>
            </p:blipFill>
            <p:spPr>
              <a:xfrm>
                <a:off x="1716120" y="4098960"/>
                <a:ext cx="1557720" cy="7952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21" name="Picture 14" descr="G:\TRICHO 2ND PAPER\PHOTOS\DUAL CULTURE PHOTOS\T-16\T-16+SO.JPG"/>
              <p:cNvPicPr/>
              <p:nvPr/>
            </p:nvPicPr>
            <p:blipFill>
              <a:blip r:embed="rId18"/>
              <a:stretch/>
            </p:blipFill>
            <p:spPr>
              <a:xfrm>
                <a:off x="3358440" y="4098960"/>
                <a:ext cx="1509120" cy="7952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22" name="Picture 15" descr="G:\TRICHO 2ND PAPER\PHOTOS\DUAL CULTURE PHOTOS\T-16\T-16+SR.JPG"/>
              <p:cNvPicPr/>
              <p:nvPr/>
            </p:nvPicPr>
            <p:blipFill>
              <a:blip r:embed="rId19"/>
              <a:stretch/>
            </p:blipFill>
            <p:spPr>
              <a:xfrm>
                <a:off x="4942080" y="4098960"/>
                <a:ext cx="1527840" cy="7815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23" name="Picture 16" descr="G:\TRICHO 2ND PAPER\PHOTOS\DUAL CULTURE PHOTOS\T-16\T-16+SD.JPG"/>
              <p:cNvPicPr/>
              <p:nvPr/>
            </p:nvPicPr>
            <p:blipFill>
              <a:blip r:embed="rId20"/>
              <a:stretch/>
            </p:blipFill>
            <p:spPr>
              <a:xfrm>
                <a:off x="6556680" y="4138560"/>
                <a:ext cx="1555560" cy="75528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24" name="Picture 17" descr="G:\TRICHO 2ND PAPER\PHOTOS\DUAL CULTURE PHOTOS\T-22\T-22+RS.JPG"/>
              <p:cNvPicPr/>
              <p:nvPr/>
            </p:nvPicPr>
            <p:blipFill>
              <a:blip r:embed="rId21"/>
              <a:stretch/>
            </p:blipFill>
            <p:spPr>
              <a:xfrm>
                <a:off x="1716120" y="4973760"/>
                <a:ext cx="1555560" cy="7326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25" name="Picture 18" descr="G:\TRICHO 2ND PAPER\PHOTOS\DUAL CULTURE PHOTOS\T-22\T-22+SO.JPG"/>
              <p:cNvPicPr/>
              <p:nvPr/>
            </p:nvPicPr>
            <p:blipFill>
              <a:blip r:embed="rId22"/>
              <a:stretch/>
            </p:blipFill>
            <p:spPr>
              <a:xfrm>
                <a:off x="3358440" y="4973760"/>
                <a:ext cx="1555560" cy="7423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26" name="Picture 19" descr="G:\TRICHO 2ND PAPER\PHOTOS\DUAL CULTURE PHOTOS\T-22\T-22+SR.JPG"/>
              <p:cNvPicPr/>
              <p:nvPr/>
            </p:nvPicPr>
            <p:blipFill>
              <a:blip r:embed="rId23"/>
              <a:stretch/>
            </p:blipFill>
            <p:spPr>
              <a:xfrm>
                <a:off x="4970880" y="4944240"/>
                <a:ext cx="1499040" cy="7866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27" name="Picture 20" descr="G:\TRICHO 2ND PAPER\PHOTOS\DUAL CULTURE PHOTOS\T-22\T-22+SD.JPG"/>
              <p:cNvPicPr/>
              <p:nvPr/>
            </p:nvPicPr>
            <p:blipFill>
              <a:blip r:embed="rId24"/>
              <a:stretch/>
            </p:blipFill>
            <p:spPr>
              <a:xfrm>
                <a:off x="6547320" y="4944240"/>
                <a:ext cx="1564920" cy="7520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28" name="Picture 21" descr="G:\TRICHO 2ND PAPER\PHOTOS\DUAL CULTURE PHOTOS\T-27\T-27+RS.JPG"/>
              <p:cNvPicPr/>
              <p:nvPr/>
            </p:nvPicPr>
            <p:blipFill>
              <a:blip r:embed="rId25"/>
              <a:stretch/>
            </p:blipFill>
            <p:spPr>
              <a:xfrm>
                <a:off x="1716120" y="5760720"/>
                <a:ext cx="1528200" cy="74088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29" name="Picture 22" descr="G:\TRICHO 2ND PAPER\PHOTOS\DUAL CULTURE PHOTOS\T-27\T-27+SO.JPG"/>
              <p:cNvPicPr/>
              <p:nvPr/>
            </p:nvPicPr>
            <p:blipFill>
              <a:blip r:embed="rId26"/>
              <a:stretch/>
            </p:blipFill>
            <p:spPr>
              <a:xfrm flipH="1">
                <a:off x="3358080" y="5769000"/>
                <a:ext cx="1555560" cy="7452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30" name="Picture 23" descr="G:\TRICHO 2ND PAPER\PHOTOS\DUAL CULTURE PHOTOS\T-27\T-27+SR.JPG"/>
              <p:cNvPicPr/>
              <p:nvPr/>
            </p:nvPicPr>
            <p:blipFill>
              <a:blip r:embed="rId27"/>
              <a:stretch/>
            </p:blipFill>
            <p:spPr>
              <a:xfrm>
                <a:off x="5006160" y="5787000"/>
                <a:ext cx="1463760" cy="7344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31" name="Picture 24" descr="G:\TRICHO 2ND PAPER\PHOTOS\DUAL CULTURE PHOTOS\T-27\T-27+SD.JPG"/>
              <p:cNvPicPr/>
              <p:nvPr/>
            </p:nvPicPr>
            <p:blipFill>
              <a:blip r:embed="rId28"/>
              <a:stretch/>
            </p:blipFill>
            <p:spPr>
              <a:xfrm>
                <a:off x="6556680" y="5799960"/>
                <a:ext cx="1555560" cy="75276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32" name="TextBox 10"/>
              <p:cNvSpPr/>
              <p:nvPr/>
            </p:nvSpPr>
            <p:spPr>
              <a:xfrm>
                <a:off x="0" y="380880"/>
                <a:ext cx="9144000" cy="398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IN" sz="1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                                  </a:t>
                </a:r>
                <a:r>
                  <a:rPr b="1" i="1" lang="en-IN" sz="2000" spc="-1" strike="noStrike">
                    <a:solidFill>
                      <a:srgbClr val="00b050"/>
                    </a:solidFill>
                    <a:latin typeface="Times New Roman"/>
                    <a:ea typeface="Times New Roman"/>
                  </a:rPr>
                  <a:t>R.solani          S.oryzae           S.rolfsii            S.delphini</a:t>
                </a:r>
                <a:endParaRPr b="0" lang="en-US" sz="2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3" name="Rectangle 11"/>
              <p:cNvSpPr/>
              <p:nvPr/>
            </p:nvSpPr>
            <p:spPr>
              <a:xfrm>
                <a:off x="1066680" y="837720"/>
                <a:ext cx="533160" cy="8876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IN" sz="1000" spc="-1" strike="noStrike">
                    <a:solidFill>
                      <a:srgbClr val="c00000"/>
                    </a:solidFill>
                    <a:latin typeface="Arial Black"/>
                    <a:ea typeface="Times New Roman"/>
                  </a:rPr>
                  <a:t>CRRIT-1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IN" sz="1000" spc="-1" strike="noStrike">
                    <a:solidFill>
                      <a:srgbClr val="c00000"/>
                    </a:solidFill>
                    <a:latin typeface="Arial Black"/>
                    <a:ea typeface="Times New Roman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IN" sz="1000" spc="-1" strike="noStrike">
                    <a:solidFill>
                      <a:srgbClr val="c00000"/>
                    </a:solidFill>
                    <a:latin typeface="Arial Black"/>
                    <a:ea typeface="Times New Roman"/>
                  </a:rPr>
                  <a:t>CRRIT-2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IN" sz="1000" spc="-1" strike="noStrike">
                    <a:solidFill>
                      <a:srgbClr val="c00000"/>
                    </a:solidFill>
                    <a:latin typeface="Arial Black"/>
                    <a:ea typeface="Times New Roman"/>
                  </a:rPr>
                  <a:t>CRRIT-3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IN" sz="1000" spc="-1" strike="noStrike">
                    <a:solidFill>
                      <a:srgbClr val="c00000"/>
                    </a:solidFill>
                    <a:latin typeface="Arial Black"/>
                    <a:ea typeface="Times New Roman"/>
                  </a:rPr>
                  <a:t>CRRIT-15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IN" sz="1000" spc="-1" strike="noStrike">
                    <a:solidFill>
                      <a:srgbClr val="c00000"/>
                    </a:solidFill>
                    <a:latin typeface="Arial Black"/>
                    <a:ea typeface="Times New Roman"/>
                  </a:rPr>
                  <a:t>CRRIT-16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IN" sz="1000" spc="-1" strike="noStrike">
                    <a:solidFill>
                      <a:srgbClr val="c00000"/>
                    </a:solidFill>
                    <a:latin typeface="Arial Black"/>
                    <a:ea typeface="Times New Roman"/>
                  </a:rPr>
                  <a:t> </a:t>
                </a:r>
                <a:r>
                  <a:rPr b="1" lang="en-IN" sz="1000" spc="-1" strike="noStrike">
                    <a:solidFill>
                      <a:srgbClr val="c00000"/>
                    </a:solidFill>
                    <a:latin typeface="Arial Black"/>
                    <a:ea typeface="Times New Roman"/>
                  </a:rPr>
                  <a:t>CRRIT-22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IN" sz="1000" spc="-1" strike="noStrike">
                    <a:solidFill>
                      <a:srgbClr val="c00000"/>
                    </a:solidFill>
                    <a:latin typeface="Arial Black"/>
                    <a:ea typeface="Times New Roman"/>
                  </a:rPr>
                  <a:t>CRRIT-27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134" name="TextBox 12"/>
            <p:cNvSpPr/>
            <p:nvPr/>
          </p:nvSpPr>
          <p:spPr>
            <a:xfrm>
              <a:off x="0" y="6488280"/>
              <a:ext cx="91440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IN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S-1 F-2: Confrontation assay showing inhibition of pathogen by </a:t>
              </a:r>
              <a:r>
                <a:rPr b="1" i="1" lang="en-IN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Trichoderma spp. 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5" name="Group 3"/>
          <p:cNvGrpSpPr/>
          <p:nvPr/>
        </p:nvGrpSpPr>
        <p:grpSpPr>
          <a:xfrm>
            <a:off x="0" y="-4680"/>
            <a:ext cx="9144000" cy="6544440"/>
            <a:chOff x="0" y="-4680"/>
            <a:chExt cx="9144000" cy="6544440"/>
          </a:xfrm>
        </p:grpSpPr>
        <p:pic>
          <p:nvPicPr>
            <p:cNvPr id="136" name="Picture 2" descr="G:\TRICHO 2ND PAPER\PHOTOS\ANNAPURNA\PAPER .JPG"/>
            <p:cNvPicPr/>
            <p:nvPr/>
          </p:nvPicPr>
          <p:blipFill>
            <a:blip r:embed="rId1"/>
            <a:stretch/>
          </p:blipFill>
          <p:spPr>
            <a:xfrm>
              <a:off x="380880" y="-4680"/>
              <a:ext cx="7944480" cy="5796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37" name="TextBox 2"/>
            <p:cNvSpPr/>
            <p:nvPr/>
          </p:nvSpPr>
          <p:spPr>
            <a:xfrm>
              <a:off x="0" y="5791320"/>
              <a:ext cx="9144000" cy="748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IN" sz="1500" spc="-1" strike="noStrike">
                  <a:solidFill>
                    <a:srgbClr val="ff0000"/>
                  </a:solidFill>
                  <a:latin typeface="Times New Roman"/>
                  <a:ea typeface="Times New Roman"/>
                </a:rPr>
                <a:t>                   </a:t>
              </a:r>
              <a:r>
                <a:rPr b="1" lang="en-IN" sz="1500" spc="-1" strike="noStrike">
                  <a:solidFill>
                    <a:srgbClr val="ff0000"/>
                  </a:solidFill>
                  <a:latin typeface="Times New Roman"/>
                  <a:ea typeface="Times New Roman"/>
                </a:rPr>
                <a:t>T0      CRRIT1    CRRI T2   CRRI T3   CRRI T15  CRRIT16    CRRIT22   CRRIT27</a:t>
              </a:r>
              <a:endParaRPr b="0" lang="en-US" sz="1500" spc="-1" strike="noStrike">
                <a:solidFill>
                  <a:srgbClr val="000000"/>
                </a:solidFill>
                <a:latin typeface="Calibri"/>
              </a:endParaRPr>
            </a:p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IN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S-1 F-3 : Effect of </a:t>
              </a:r>
              <a:r>
                <a:rPr b="1" i="1" lang="en-IN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Trichoderma spp</a:t>
              </a:r>
              <a:r>
                <a:rPr b="1" lang="en-IN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. Seed dressing on seedlings of rice variety Annapurna (T0=control, T1, T2, T3, T15, T16,T22&amp; T27 are different spp. of </a:t>
              </a:r>
              <a:r>
                <a:rPr b="1" i="1" lang="en-IN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Trichoderma</a:t>
              </a:r>
              <a:r>
                <a:rPr b="1" lang="en-IN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).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8" name="Picture 2" descr="G:\TRICHO 2ND PAPER\PHOTOS\SATABDI\PAPER.JPG"/>
          <p:cNvPicPr/>
          <p:nvPr/>
        </p:nvPicPr>
        <p:blipFill>
          <a:blip r:embed="rId1"/>
          <a:stretch/>
        </p:blipFill>
        <p:spPr>
          <a:xfrm>
            <a:off x="304920" y="46080"/>
            <a:ext cx="8076960" cy="5516640"/>
          </a:xfrm>
          <a:prstGeom prst="rect">
            <a:avLst/>
          </a:prstGeom>
          <a:ln w="0">
            <a:noFill/>
          </a:ln>
        </p:spPr>
      </p:pic>
      <p:sp>
        <p:nvSpPr>
          <p:cNvPr id="139" name="TextBox 2"/>
          <p:cNvSpPr/>
          <p:nvPr/>
        </p:nvSpPr>
        <p:spPr>
          <a:xfrm>
            <a:off x="0" y="5562720"/>
            <a:ext cx="9144000" cy="748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IN" sz="15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                   </a:t>
            </a:r>
            <a:r>
              <a:rPr b="1" lang="en-IN" sz="15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T0      CRRIT1    CRRI T2   CRRI T3   CRRI T15  CRRIT16    CRRIT22   CRRIT27</a:t>
            </a:r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IN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-1 F-4: Effect of </a:t>
            </a:r>
            <a:r>
              <a:rPr b="1" i="1" lang="en-IN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richoderma spp</a:t>
            </a:r>
            <a:r>
              <a:rPr b="1" lang="en-IN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 Seed dressing on seedlings of rice variety Satabdi (T0=control, T1, T2, T3, T15, T16,T22&amp; T27 are different spp. of </a:t>
            </a:r>
            <a:r>
              <a:rPr b="1" i="1" lang="en-IN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richoderma</a:t>
            </a:r>
            <a:r>
              <a:rPr b="1" lang="en-IN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.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8-16T00:00:00Z</dcterms:created>
  <dc:creator>LENOVO</dc:creator>
  <dc:description/>
  <dc:language>en-US</dc:language>
  <cp:lastModifiedBy>LENOVO</cp:lastModifiedBy>
  <dcterms:modified xsi:type="dcterms:W3CDTF">2020-04-15T18:06:59Z</dcterms:modified>
  <cp:revision>1</cp:revision>
  <dc:subject/>
  <dc:title>Slide 1</dc:title>
</cp:coreProperties>
</file>